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469"/>
    <p:restoredTop sz="94725"/>
  </p:normalViewPr>
  <p:slideViewPr>
    <p:cSldViewPr snapToGrid="0" snapToObjects="1">
      <p:cViewPr>
        <p:scale>
          <a:sx n="171" d="100"/>
          <a:sy n="171" d="100"/>
        </p:scale>
        <p:origin x="-600" y="-43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DB6C1-02AF-B747-B993-BBA29C30BCFE}" type="datetimeFigureOut">
              <a:t>2023/8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CAF25B-06E4-974C-8A4A-40C895AF9C9B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41429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ECAF25B-06E4-974C-8A4A-40C895AF9C9B}" type="slidenum">
              <a:rPr lang="en-US" altLang="ja-JP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04874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dirty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154A7-7B19-614E-89EC-5B5992BFC405}" type="datetimeFigureOut">
              <a:t>2023/8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95BFB-70FA-E847-8C49-1B6C7524D158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7300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154A7-7B19-614E-89EC-5B5992BFC405}" type="datetimeFigureOut">
              <a:t>2023/8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95BFB-70FA-E847-8C49-1B6C7524D158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3450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154A7-7B19-614E-89EC-5B5992BFC405}" type="datetimeFigureOut">
              <a:t>2023/8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95BFB-70FA-E847-8C49-1B6C7524D158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90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154A7-7B19-614E-89EC-5B5992BFC405}" type="datetimeFigureOut">
              <a:t>2023/8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95BFB-70FA-E847-8C49-1B6C7524D158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0511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154A7-7B19-614E-89EC-5B5992BFC405}" type="datetimeFigureOut">
              <a:t>2023/8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95BFB-70FA-E847-8C49-1B6C7524D158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7693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154A7-7B19-614E-89EC-5B5992BFC405}" type="datetimeFigureOut">
              <a:t>2023/8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95BFB-70FA-E847-8C49-1B6C7524D158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34528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154A7-7B19-614E-89EC-5B5992BFC405}" type="datetimeFigureOut">
              <a:t>2023/8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95BFB-70FA-E847-8C49-1B6C7524D158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6289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154A7-7B19-614E-89EC-5B5992BFC405}" type="datetimeFigureOut">
              <a:t>2023/8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95BFB-70FA-E847-8C49-1B6C7524D158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816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154A7-7B19-614E-89EC-5B5992BFC405}" type="datetimeFigureOut">
              <a:t>2023/8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95BFB-70FA-E847-8C49-1B6C7524D158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2794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154A7-7B19-614E-89EC-5B5992BFC405}" type="datetimeFigureOut">
              <a:t>2023/8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95BFB-70FA-E847-8C49-1B6C7524D158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281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154A7-7B19-614E-89EC-5B5992BFC405}" type="datetimeFigureOut">
              <a:t>2023/8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95BFB-70FA-E847-8C49-1B6C7524D158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4465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E154A7-7B19-614E-89EC-5B5992BFC405}" type="datetimeFigureOut">
              <a:t>2023/8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95BFB-70FA-E847-8C49-1B6C7524D158}" type="slidenum">
              <a:rPr lang="en-US" altLang="ja-JP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7706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図 34">
            <a:extLst>
              <a:ext uri="{FF2B5EF4-FFF2-40B4-BE49-F238E27FC236}">
                <a16:creationId xmlns:a16="http://schemas.microsoft.com/office/drawing/2014/main" id="{AFE5622D-174D-8575-5E3B-88A64E055F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0292" y="6184004"/>
            <a:ext cx="5137403" cy="1712468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35EB9F17-438B-ED28-474F-27FE8263D7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0293" y="7999768"/>
            <a:ext cx="5137403" cy="1712468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0FAB6C41-D898-3EEC-7AE6-A537C951791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60293" y="4342082"/>
            <a:ext cx="5137403" cy="1712468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A6112A3A-C20E-C591-1170-4FAFF521F76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60294" y="657588"/>
            <a:ext cx="5137403" cy="1712468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88A127A-459E-4F38-ED5E-8442E99C70B7}"/>
              </a:ext>
            </a:extLst>
          </p:cNvPr>
          <p:cNvSpPr txBox="1"/>
          <p:nvPr/>
        </p:nvSpPr>
        <p:spPr>
          <a:xfrm>
            <a:off x="161582" y="126540"/>
            <a:ext cx="185820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ja-JP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8" name="図 27">
            <a:extLst>
              <a:ext uri="{FF2B5EF4-FFF2-40B4-BE49-F238E27FC236}">
                <a16:creationId xmlns:a16="http://schemas.microsoft.com/office/drawing/2014/main" id="{75BE2784-78A6-1452-D2F9-514A39F41B1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60293" y="2505034"/>
            <a:ext cx="5137409" cy="171247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4A357BC-6184-E708-6551-423C09B4D2EE}"/>
              </a:ext>
            </a:extLst>
          </p:cNvPr>
          <p:cNvSpPr txBox="1"/>
          <p:nvPr/>
        </p:nvSpPr>
        <p:spPr>
          <a:xfrm>
            <a:off x="860303" y="426622"/>
            <a:ext cx="68005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>
                <a:latin typeface="Times New Roman" panose="02020603050405020304" pitchFamily="18" charset="0"/>
                <a:cs typeface="Times New Roman" panose="02020603050405020304" pitchFamily="18" charset="0"/>
              </a:rPr>
              <a:t>A: Age</a:t>
            </a:r>
            <a:endParaRPr lang="ja-JP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7398402-7059-9273-DDFC-5C03BA6C06EC}"/>
              </a:ext>
            </a:extLst>
          </p:cNvPr>
          <p:cNvSpPr txBox="1"/>
          <p:nvPr/>
        </p:nvSpPr>
        <p:spPr>
          <a:xfrm>
            <a:off x="860303" y="2274482"/>
            <a:ext cx="74251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>
                <a:latin typeface="Times New Roman" panose="02020603050405020304" pitchFamily="18" charset="0"/>
                <a:cs typeface="Times New Roman" panose="02020603050405020304" pitchFamily="18" charset="0"/>
              </a:rPr>
              <a:t>B:WBC</a:t>
            </a:r>
            <a:endParaRPr lang="ja-JP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043FAE6-4F7D-B23D-6196-B8E71017839A}"/>
              </a:ext>
            </a:extLst>
          </p:cNvPr>
          <p:cNvSpPr txBox="1"/>
          <p:nvPr/>
        </p:nvSpPr>
        <p:spPr>
          <a:xfrm>
            <a:off x="860303" y="4114077"/>
            <a:ext cx="256999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>
                <a:latin typeface="Times New Roman" panose="02020603050405020304" pitchFamily="18" charset="0"/>
                <a:cs typeface="Times New Roman" panose="02020603050405020304" pitchFamily="18" charset="0"/>
              </a:rPr>
              <a:t>C: Monocyte-to-Lymphocyte ratio</a:t>
            </a:r>
            <a:endParaRPr lang="ja-JP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E423527-F698-EE03-CEE9-F159438C3EE2}"/>
              </a:ext>
            </a:extLst>
          </p:cNvPr>
          <p:cNvSpPr txBox="1"/>
          <p:nvPr/>
        </p:nvSpPr>
        <p:spPr>
          <a:xfrm>
            <a:off x="860302" y="5955860"/>
            <a:ext cx="92044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>
                <a:latin typeface="Times New Roman" panose="02020603050405020304" pitchFamily="18" charset="0"/>
                <a:cs typeface="Times New Roman" panose="02020603050405020304" pitchFamily="18" charset="0"/>
              </a:rPr>
              <a:t>D: Platelet</a:t>
            </a:r>
            <a:endParaRPr lang="ja-JP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3CA321F-FC23-0285-8CC5-76FC89BB992D}"/>
              </a:ext>
            </a:extLst>
          </p:cNvPr>
          <p:cNvSpPr txBox="1"/>
          <p:nvPr/>
        </p:nvSpPr>
        <p:spPr>
          <a:xfrm>
            <a:off x="860300" y="7794361"/>
            <a:ext cx="73770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>
                <a:latin typeface="Times New Roman" panose="02020603050405020304" pitchFamily="18" charset="0"/>
                <a:cs typeface="Times New Roman" panose="02020603050405020304" pitchFamily="18" charset="0"/>
              </a:rPr>
              <a:t>E: LDH</a:t>
            </a:r>
            <a:endParaRPr lang="ja-JP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6D931DB-722E-E19A-A29D-7C12FDCB7EB4}"/>
              </a:ext>
            </a:extLst>
          </p:cNvPr>
          <p:cNvSpPr txBox="1"/>
          <p:nvPr/>
        </p:nvSpPr>
        <p:spPr>
          <a:xfrm>
            <a:off x="1836314" y="1617478"/>
            <a:ext cx="648119" cy="485415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no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Cutoff 73 years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e 44.7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p 68.6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57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605206A5-E7ED-9930-B2B9-F924B8F323C6}"/>
              </a:ext>
            </a:extLst>
          </p:cNvPr>
          <p:cNvSpPr txBox="1"/>
          <p:nvPr/>
        </p:nvSpPr>
        <p:spPr>
          <a:xfrm>
            <a:off x="3550706" y="1617477"/>
            <a:ext cx="648119" cy="485415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sp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Cutoff 72 years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e 52.1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p 67.0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61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B84DA46-97F6-2970-6214-900E27652E8A}"/>
              </a:ext>
            </a:extLst>
          </p:cNvPr>
          <p:cNvSpPr txBox="1"/>
          <p:nvPr/>
        </p:nvSpPr>
        <p:spPr>
          <a:xfrm>
            <a:off x="5266478" y="1953106"/>
            <a:ext cx="648119" cy="144073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sp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50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97C95ED-0195-3504-0FAF-98EBEF857011}"/>
              </a:ext>
            </a:extLst>
          </p:cNvPr>
          <p:cNvSpPr txBox="1"/>
          <p:nvPr/>
        </p:nvSpPr>
        <p:spPr>
          <a:xfrm>
            <a:off x="1790500" y="3454526"/>
            <a:ext cx="693933" cy="485415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no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Cutoff 6.3x10</a:t>
            </a:r>
            <a:r>
              <a:rPr lang="en-US" altLang="ja-JP" sz="7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/L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e 56.6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p 61.6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60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81C910D-EF95-5EBF-2561-3A1DCCCD67B7}"/>
              </a:ext>
            </a:extLst>
          </p:cNvPr>
          <p:cNvSpPr txBox="1"/>
          <p:nvPr/>
        </p:nvSpPr>
        <p:spPr>
          <a:xfrm>
            <a:off x="3504892" y="3471965"/>
            <a:ext cx="693933" cy="467239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sp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Cutoff 6.3x10</a:t>
            </a:r>
            <a:r>
              <a:rPr lang="en-US" altLang="ja-JP" sz="7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/L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e 60.4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p 62.7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63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4CCA7BE-5963-CC27-4BC1-D77EAB313A44}"/>
              </a:ext>
            </a:extLst>
          </p:cNvPr>
          <p:cNvSpPr txBox="1"/>
          <p:nvPr/>
        </p:nvSpPr>
        <p:spPr>
          <a:xfrm>
            <a:off x="5266478" y="3790154"/>
            <a:ext cx="648119" cy="144073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sp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54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AF152D8-50EA-0C5C-4283-7215F25BC87B}"/>
              </a:ext>
            </a:extLst>
          </p:cNvPr>
          <p:cNvSpPr txBox="1"/>
          <p:nvPr/>
        </p:nvSpPr>
        <p:spPr>
          <a:xfrm>
            <a:off x="1836314" y="5303730"/>
            <a:ext cx="648119" cy="485415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no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Cutoff 0.625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e 65.8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p 59.7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62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1E27E8F-3823-1977-E8E7-52FBBC3B0754}"/>
              </a:ext>
            </a:extLst>
          </p:cNvPr>
          <p:cNvSpPr txBox="1"/>
          <p:nvPr/>
        </p:nvSpPr>
        <p:spPr>
          <a:xfrm>
            <a:off x="3550706" y="5303729"/>
            <a:ext cx="648119" cy="485415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sp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Cutoff 0.625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e 77.1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p 56.0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66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B2A3B66-8DD1-069B-8211-2A23E80640CA}"/>
              </a:ext>
            </a:extLst>
          </p:cNvPr>
          <p:cNvSpPr txBox="1"/>
          <p:nvPr/>
        </p:nvSpPr>
        <p:spPr>
          <a:xfrm>
            <a:off x="5266478" y="5639358"/>
            <a:ext cx="648119" cy="144073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sp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57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0C29D6B-4212-3BD2-E6E0-4C2B2C7BE21A}"/>
              </a:ext>
            </a:extLst>
          </p:cNvPr>
          <p:cNvSpPr txBox="1"/>
          <p:nvPr/>
        </p:nvSpPr>
        <p:spPr>
          <a:xfrm>
            <a:off x="1762421" y="7142027"/>
            <a:ext cx="722012" cy="485415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no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Cutoff 138x10</a:t>
            </a:r>
            <a:r>
              <a:rPr lang="en-US" altLang="ja-JP" sz="7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/L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e 50.0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p 73.6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64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CB71B04-6AED-7D70-BBB6-0829104F6730}"/>
              </a:ext>
            </a:extLst>
          </p:cNvPr>
          <p:cNvSpPr txBox="1"/>
          <p:nvPr/>
        </p:nvSpPr>
        <p:spPr>
          <a:xfrm>
            <a:off x="3483548" y="7156282"/>
            <a:ext cx="722012" cy="467239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sp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Cutoff 154x10</a:t>
            </a:r>
            <a:r>
              <a:rPr lang="en-US" altLang="ja-JP" sz="7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/L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e 75.0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p 67.8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74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8ABB5FC-61BC-2D03-09BF-0E03923E421C}"/>
              </a:ext>
            </a:extLst>
          </p:cNvPr>
          <p:cNvSpPr txBox="1"/>
          <p:nvPr/>
        </p:nvSpPr>
        <p:spPr>
          <a:xfrm>
            <a:off x="5266478" y="7491911"/>
            <a:ext cx="648119" cy="144073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sp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52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9317225-699A-7ABF-183E-C94F78D6D47A}"/>
              </a:ext>
            </a:extLst>
          </p:cNvPr>
          <p:cNvSpPr txBox="1"/>
          <p:nvPr/>
        </p:nvSpPr>
        <p:spPr>
          <a:xfrm>
            <a:off x="1754895" y="8952158"/>
            <a:ext cx="734325" cy="485415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no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Cutoff 404 IU/L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e 59.2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p 74.0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69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9AEA8A2-24B4-0689-DBCB-8EE5900E636C}"/>
              </a:ext>
            </a:extLst>
          </p:cNvPr>
          <p:cNvSpPr txBox="1"/>
          <p:nvPr/>
        </p:nvSpPr>
        <p:spPr>
          <a:xfrm>
            <a:off x="3469287" y="8970946"/>
            <a:ext cx="734325" cy="467239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sp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Cutoff 407 IU/L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e 72.9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  Sp 74.0%</a:t>
            </a:r>
          </a:p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77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16F547A-D4BD-56E1-ED34-70CC788D63DA}"/>
              </a:ext>
            </a:extLst>
          </p:cNvPr>
          <p:cNvSpPr txBox="1"/>
          <p:nvPr/>
        </p:nvSpPr>
        <p:spPr>
          <a:xfrm>
            <a:off x="5266478" y="9300312"/>
            <a:ext cx="648119" cy="144073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18000" rIns="36000" bIns="18000" rtlCol="0">
            <a:spAutoFit/>
          </a:bodyPr>
          <a:lstStyle/>
          <a:p>
            <a:r>
              <a:rPr lang="en-US" altLang="ja-JP" sz="700">
                <a:latin typeface="Times New Roman" panose="02020603050405020304" pitchFamily="18" charset="0"/>
                <a:cs typeface="Times New Roman" panose="02020603050405020304" pitchFamily="18" charset="0"/>
              </a:rPr>
              <a:t>AUROC 0.55</a:t>
            </a:r>
          </a:p>
        </p:txBody>
      </p:sp>
    </p:spTree>
    <p:extLst>
      <p:ext uri="{BB962C8B-B14F-4D97-AF65-F5344CB8AC3E}">
        <p14:creationId xmlns:p14="http://schemas.microsoft.com/office/powerpoint/2010/main" val="2647995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72</TotalTime>
  <Words>166</Words>
  <Application>Microsoft Macintosh PowerPoint</Application>
  <PresentationFormat>A4 210 x 297 mm</PresentationFormat>
  <Paragraphs>5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nda Naoki</dc:creator>
  <cp:lastModifiedBy>Naoki Kanda</cp:lastModifiedBy>
  <cp:revision>180</cp:revision>
  <cp:lastPrinted>2022-11-21T01:17:41Z</cp:lastPrinted>
  <dcterms:created xsi:type="dcterms:W3CDTF">2021-09-17T03:27:29Z</dcterms:created>
  <dcterms:modified xsi:type="dcterms:W3CDTF">2023-08-02T10:55:34Z</dcterms:modified>
</cp:coreProperties>
</file>